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49" autoAdjust="0"/>
    <p:restoredTop sz="94660"/>
  </p:normalViewPr>
  <p:slideViewPr>
    <p:cSldViewPr snapToGrid="0">
      <p:cViewPr>
        <p:scale>
          <a:sx n="300" d="100"/>
          <a:sy n="300" d="100"/>
        </p:scale>
        <p:origin x="216" y="-124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695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3943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5802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383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2085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9426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6931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792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988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2906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900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03460-C33B-42FE-851B-DA7FEC75A6E1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9EC84-4AF2-49D6-95A5-737FEFD839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1257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073B7CE3-303F-4A32-A542-270AE1DBF7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6" y="52349"/>
            <a:ext cx="6851927" cy="8729501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3E478392-BEF2-4DA8-B643-40C80E93180F}"/>
              </a:ext>
            </a:extLst>
          </p:cNvPr>
          <p:cNvSpPr/>
          <p:nvPr/>
        </p:nvSpPr>
        <p:spPr>
          <a:xfrm>
            <a:off x="0" y="8890000"/>
            <a:ext cx="6858000" cy="254000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3. GWAS analyses and Manhattan plots resulted from all possible combinations of the seed color-associated traits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0284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9</TotalTime>
  <Words>19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JinHyun</dc:creator>
  <cp:lastModifiedBy>김 진현</cp:lastModifiedBy>
  <cp:revision>33</cp:revision>
  <dcterms:created xsi:type="dcterms:W3CDTF">2018-07-31T05:32:22Z</dcterms:created>
  <dcterms:modified xsi:type="dcterms:W3CDTF">2020-04-24T15:38:39Z</dcterms:modified>
</cp:coreProperties>
</file>